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57" r:id="rId5"/>
    <p:sldId id="262" r:id="rId6"/>
    <p:sldId id="263" r:id="rId7"/>
    <p:sldId id="264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3843895-6784-B944-9493-403CA9D4DB3E}" v="2" dt="2023-05-02T09:03:36.16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8328"/>
    <p:restoredTop sz="95833"/>
  </p:normalViewPr>
  <p:slideViewPr>
    <p:cSldViewPr snapToGrid="0">
      <p:cViewPr varScale="1">
        <p:scale>
          <a:sx n="103" d="100"/>
          <a:sy n="103" d="100"/>
        </p:scale>
        <p:origin x="144" y="2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D2F9FF-0779-386C-5D37-50518EC824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58DBA8A-554E-0B29-8033-17CFA16F91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CB4598-382E-5B84-5916-E2FCF13C2B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D3F5D-3D7A-664D-8D51-C107ED9DA0F2}" type="datetimeFigureOut">
              <a:rPr lang="en-GB" smtClean="0"/>
              <a:t>04/05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0B09C5-B6CB-83AB-758C-9C47AA499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10B593-C6A8-7788-CFD8-F947638BE3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EBF56-A245-124E-82BB-9FC158EBB6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6950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5DE65F-D83A-6B8E-238A-4829B6B081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8AEE0B-E4DA-2DE9-B30E-EF2E504538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A2F946-0075-7388-57E5-748E4E416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D3F5D-3D7A-664D-8D51-C107ED9DA0F2}" type="datetimeFigureOut">
              <a:rPr lang="en-GB" smtClean="0"/>
              <a:t>04/05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C4AD10-B9ED-5335-BAC1-5B717E8E09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EC39C8-6914-ADF8-5B09-0763428B18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EBF56-A245-124E-82BB-9FC158EBB6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7219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225AC8B-0446-8145-3C23-C3B136DFF2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A56D12-DD6F-247A-EA73-ECAC0CE882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7CDC47-1270-932F-5753-104CB7CB30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D3F5D-3D7A-664D-8D51-C107ED9DA0F2}" type="datetimeFigureOut">
              <a:rPr lang="en-GB" smtClean="0"/>
              <a:t>04/05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5DC08C-DA92-B8F1-71BB-5EDC705EC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70F10F-3BEA-1296-1953-4B83261D3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EBF56-A245-124E-82BB-9FC158EBB6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86418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D39870-E60A-8F96-30DB-38B36025F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36FBB5-A760-4893-364A-62C9C228B1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E37E79-6883-2F07-83B6-41E43A7F2B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D3F5D-3D7A-664D-8D51-C107ED9DA0F2}" type="datetimeFigureOut">
              <a:rPr lang="en-GB" smtClean="0"/>
              <a:t>04/05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627B04-71B2-244C-9BCF-E731ED007A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348A09-820B-3A4F-BA4D-7DDFED907B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EBF56-A245-124E-82BB-9FC158EBB6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8412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66ED95-3473-D3AE-3848-0E819ED96D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442D12-0CB4-B94F-2CBA-77D0235366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5D60D0-762C-D613-573A-6A4D59B9E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D3F5D-3D7A-664D-8D51-C107ED9DA0F2}" type="datetimeFigureOut">
              <a:rPr lang="en-GB" smtClean="0"/>
              <a:t>04/05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4CD3D6-A824-59CC-A54B-4761A321B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678802-79A3-4CA8-B830-50FDE4AB1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EBF56-A245-124E-82BB-9FC158EBB6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67858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E0F225-261F-4986-E0CD-D63618587C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B72B63-7294-4FEA-96C7-03C564AB7D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52B7B9-9B1B-6A32-E1F5-CC1F2062F7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6D94CD-0ED5-48ED-A963-F290021336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D3F5D-3D7A-664D-8D51-C107ED9DA0F2}" type="datetimeFigureOut">
              <a:rPr lang="en-GB" smtClean="0"/>
              <a:t>04/05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27270F-68E9-D869-E7B6-459320A39E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A145E6-1F32-208D-7B59-E6637CA9A9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EBF56-A245-124E-82BB-9FC158EBB6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7830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94D784-0725-757C-782B-2A8E34AF15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5F1E84-B4D3-BEA0-5598-C0FD4DF72B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63B402-D83D-A052-0968-4E78775FDB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ACC4A79-618F-E4DB-AC66-C3572FD866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FCF200-D0B5-90EA-9D26-4834A8C00B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8EF8B58-95D3-D9B0-A92B-3142677815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D3F5D-3D7A-664D-8D51-C107ED9DA0F2}" type="datetimeFigureOut">
              <a:rPr lang="en-GB" smtClean="0"/>
              <a:t>04/05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4AE14B5-01CD-C39C-1544-F77B45AD2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ECA85BB-A772-F1EC-C7F0-54B0AFD7DB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EBF56-A245-124E-82BB-9FC158EBB6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2913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CCF008-8CEF-330C-23AB-FBB80C10FF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D02A19D-4DC7-3356-F6A7-EC5C8DD31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D3F5D-3D7A-664D-8D51-C107ED9DA0F2}" type="datetimeFigureOut">
              <a:rPr lang="en-GB" smtClean="0"/>
              <a:t>04/05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68C1DAA-77A5-D8D2-C1C2-A1EED72A06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50BA86F-9394-11F3-E6CD-ABC6C8F312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EBF56-A245-124E-82BB-9FC158EBB6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8444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87F91FF-1B9B-066D-EC5F-D670F95582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D3F5D-3D7A-664D-8D51-C107ED9DA0F2}" type="datetimeFigureOut">
              <a:rPr lang="en-GB" smtClean="0"/>
              <a:t>04/05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CF811C8-033E-0C57-4142-8CB6383FA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87DF25E-491A-9960-0C42-274366BA7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EBF56-A245-124E-82BB-9FC158EBB6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2963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E1B297-9797-085A-5588-3D0870423C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50E19B-DC8B-6E6C-D8DC-6F2C967F4D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1FAD9E-A4F6-3D2B-D0B8-916D3A2F00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9B0682-833B-BE59-D75B-44CD8BAC05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D3F5D-3D7A-664D-8D51-C107ED9DA0F2}" type="datetimeFigureOut">
              <a:rPr lang="en-GB" smtClean="0"/>
              <a:t>04/05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5D199E-F87B-6980-BF99-22A77EFFFC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40C251-247A-01AA-B65C-923DAACC5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EBF56-A245-124E-82BB-9FC158EBB6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6771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61ABC4-CEAA-BA9D-B452-F33B739547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EF6C3D6-0069-5A26-2093-1E16930C68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7413E0-03D8-E522-F184-F55652C3C4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17BC02-994E-F09D-252F-5439E4A40E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D3F5D-3D7A-664D-8D51-C107ED9DA0F2}" type="datetimeFigureOut">
              <a:rPr lang="en-GB" smtClean="0"/>
              <a:t>04/05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A10426-1A22-3BEA-57AF-B8FB1BFE98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FB979E-C70B-061F-CF28-678946F28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EBF56-A245-124E-82BB-9FC158EBB6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7743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14F8A71-C678-142C-E31D-3AA1363D87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A5857B-75C6-9238-633D-2938E2D550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5AE2FC-1758-BC65-BB41-193A5B5856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0D3F5D-3D7A-664D-8D51-C107ED9DA0F2}" type="datetimeFigureOut">
              <a:rPr lang="en-GB" smtClean="0"/>
              <a:t>04/05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E2B8ED-B0E3-0225-EE0E-489D4D6BFB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9AA9F0-AA52-9116-741D-BE552230B7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4EBF56-A245-124E-82BB-9FC158EBB6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09873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09C17863-1275-2AD1-1F99-41C7CD6236A3}"/>
              </a:ext>
            </a:extLst>
          </p:cNvPr>
          <p:cNvSpPr txBox="1"/>
          <p:nvPr/>
        </p:nvSpPr>
        <p:spPr>
          <a:xfrm>
            <a:off x="165403" y="4021609"/>
            <a:ext cx="313501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Representative </a:t>
            </a:r>
            <a:r>
              <a:rPr lang="en-GB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ull length western blot images from Figure 5c confirming knockdown of MMP-2 and EMMPRIN in exosomes. Alix was used as a loading control. Exo= exosomes, HG= high glycosylated.</a:t>
            </a:r>
            <a:endParaRPr lang="en-GB" sz="900" dirty="0"/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3D4086CF-C88E-83A3-170D-D113C5F500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403" y="0"/>
            <a:ext cx="3135011" cy="4021609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01FA74CA-4964-A6D0-4141-EE7B7A1AF806}"/>
              </a:ext>
            </a:extLst>
          </p:cNvPr>
          <p:cNvSpPr txBox="1"/>
          <p:nvPr/>
        </p:nvSpPr>
        <p:spPr>
          <a:xfrm>
            <a:off x="3755440" y="2221574"/>
            <a:ext cx="4257388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Representative </a:t>
            </a:r>
            <a:r>
              <a:rPr lang="en-GB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ull length western blot images from Supplementary Figure S4c. </a:t>
            </a:r>
            <a:endParaRPr lang="en-GB" sz="9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B2E9E96-3016-C778-DD0B-ADA45A723C18}"/>
              </a:ext>
            </a:extLst>
          </p:cNvPr>
          <p:cNvSpPr txBox="1"/>
          <p:nvPr/>
        </p:nvSpPr>
        <p:spPr>
          <a:xfrm>
            <a:off x="3755440" y="4654382"/>
            <a:ext cx="431509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Representative </a:t>
            </a:r>
            <a:r>
              <a:rPr lang="en-GB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ull length western blot images from Supplementary Figure S5c. </a:t>
            </a:r>
            <a:endParaRPr lang="en-GB" sz="9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EEE89C9-BC6C-AF5A-F65F-13B785E99AD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55440" y="-330367"/>
            <a:ext cx="4191000" cy="25908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E9DBD9B-7890-7CE6-C028-91D6E0F819E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55440" y="1969874"/>
            <a:ext cx="4356100" cy="259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53684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>
            <a:extLst>
              <a:ext uri="{FF2B5EF4-FFF2-40B4-BE49-F238E27FC236}">
                <a16:creationId xmlns:a16="http://schemas.microsoft.com/office/drawing/2014/main" id="{66352493-8437-8549-C142-5849FF4D5C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88210" y="45155"/>
            <a:ext cx="2419467" cy="4943122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A066AA0A-CF2C-F3BD-711D-74D03C8288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4163" y="0"/>
            <a:ext cx="2472464" cy="3217333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020587F1-C70C-3A9F-A318-3E1BD99E11E2}"/>
              </a:ext>
            </a:extLst>
          </p:cNvPr>
          <p:cNvSpPr txBox="1"/>
          <p:nvPr/>
        </p:nvSpPr>
        <p:spPr>
          <a:xfrm>
            <a:off x="6477849" y="0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8E9F51B-A86F-2EA3-72B4-433C2DF5CB2F}"/>
              </a:ext>
            </a:extLst>
          </p:cNvPr>
          <p:cNvSpPr txBox="1"/>
          <p:nvPr/>
        </p:nvSpPr>
        <p:spPr>
          <a:xfrm>
            <a:off x="9912425" y="0"/>
            <a:ext cx="328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H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3A424FB-9C93-E01A-B9AA-294D4E62F211}"/>
              </a:ext>
            </a:extLst>
          </p:cNvPr>
          <p:cNvSpPr txBox="1"/>
          <p:nvPr/>
        </p:nvSpPr>
        <p:spPr>
          <a:xfrm>
            <a:off x="3354367" y="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</a:t>
            </a:r>
            <a:endParaRPr lang="en-GB" strike="sngStrike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E8E1B3A-B121-7D54-6891-40D6D29363D6}"/>
              </a:ext>
            </a:extLst>
          </p:cNvPr>
          <p:cNvSpPr txBox="1"/>
          <p:nvPr/>
        </p:nvSpPr>
        <p:spPr>
          <a:xfrm>
            <a:off x="-57767" y="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  <a:endParaRPr lang="en-GB" strike="sngStrike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21B879D-2245-E9AD-C73D-0C7195E8F99A}"/>
              </a:ext>
            </a:extLst>
          </p:cNvPr>
          <p:cNvSpPr txBox="1"/>
          <p:nvPr/>
        </p:nvSpPr>
        <p:spPr>
          <a:xfrm>
            <a:off x="0" y="5342139"/>
            <a:ext cx="41791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Representative </a:t>
            </a:r>
            <a:r>
              <a:rPr lang="en-GB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ull length western blot images from Supplementary Figure S7, C, D, G,H.  </a:t>
            </a:r>
            <a:endParaRPr lang="en-GB" sz="9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0349BE6-D6A8-A9B9-1891-AA1CD20A1AB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13012" y="369333"/>
            <a:ext cx="2815587" cy="348282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696DD72-6AEF-B948-DD8A-7C13E20C391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265648" y="184666"/>
            <a:ext cx="2926352" cy="36674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85851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F5F5789-B116-C041-B2DF-60BEBC60C4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2793" y="1082680"/>
            <a:ext cx="2865666" cy="125774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3EB1B74-BF84-49DA-8D1D-46B636A26D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3664" y="3065802"/>
            <a:ext cx="2929167" cy="1163298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ABC46D8-BE90-6091-90C6-F8A9AE48066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0" t="8162" r="56761" b="77868"/>
          <a:stretch/>
        </p:blipFill>
        <p:spPr>
          <a:xfrm>
            <a:off x="576202" y="278494"/>
            <a:ext cx="2766629" cy="755308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59859FD0-A7D1-3C50-176A-25C090A1AD7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" t="56972" r="54170" b="34176"/>
          <a:stretch/>
        </p:blipFill>
        <p:spPr>
          <a:xfrm>
            <a:off x="282185" y="2570622"/>
            <a:ext cx="3171352" cy="49518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447D5DDD-D20B-DDD6-6DBF-361469242F0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39436" y="278494"/>
            <a:ext cx="5970180" cy="3429906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A33B91EC-DD20-C4B9-8075-7D187927995C}"/>
              </a:ext>
            </a:extLst>
          </p:cNvPr>
          <p:cNvSpPr txBox="1"/>
          <p:nvPr/>
        </p:nvSpPr>
        <p:spPr>
          <a:xfrm>
            <a:off x="282186" y="4487206"/>
            <a:ext cx="306064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Representative </a:t>
            </a:r>
            <a:r>
              <a:rPr lang="en-GB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ull length zymography image from Figure 4A, C.</a:t>
            </a:r>
            <a:endParaRPr lang="en-GB" sz="9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DF10DE8-6D77-792C-A821-DB4147AEAC74}"/>
              </a:ext>
            </a:extLst>
          </p:cNvPr>
          <p:cNvSpPr txBox="1"/>
          <p:nvPr/>
        </p:nvSpPr>
        <p:spPr>
          <a:xfrm>
            <a:off x="5535224" y="3859768"/>
            <a:ext cx="577439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Representative </a:t>
            </a:r>
            <a:r>
              <a:rPr lang="en-GB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ull length zymography image from Figure 6C.</a:t>
            </a:r>
            <a:endParaRPr lang="en-GB" sz="9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6038C85-A58A-7B0F-7F51-F2E232749AE9}"/>
              </a:ext>
            </a:extLst>
          </p:cNvPr>
          <p:cNvSpPr txBox="1"/>
          <p:nvPr/>
        </p:nvSpPr>
        <p:spPr>
          <a:xfrm>
            <a:off x="-57767" y="244888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  <a:endParaRPr lang="en-GB" strike="sngStrike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D23350E-B617-97B4-BD1E-01A235F3037E}"/>
              </a:ext>
            </a:extLst>
          </p:cNvPr>
          <p:cNvSpPr txBox="1"/>
          <p:nvPr/>
        </p:nvSpPr>
        <p:spPr>
          <a:xfrm>
            <a:off x="-57767" y="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7758880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A94666B-D14A-1D41-8197-4B053B2860C1}"/>
              </a:ext>
            </a:extLst>
          </p:cNvPr>
          <p:cNvSpPr txBox="1"/>
          <p:nvPr/>
        </p:nvSpPr>
        <p:spPr>
          <a:xfrm rot="18462969">
            <a:off x="4658061" y="721026"/>
            <a:ext cx="1243678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425 +NT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xo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22D4A09-309A-CD5C-03C2-AE6DA7A426F6}"/>
              </a:ext>
            </a:extLst>
          </p:cNvPr>
          <p:cNvSpPr txBox="1"/>
          <p:nvPr/>
        </p:nvSpPr>
        <p:spPr>
          <a:xfrm rot="18462969">
            <a:off x="3345976" y="625057"/>
            <a:ext cx="162912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425 media ctr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8FC2192-04F7-1B66-83E5-741877594213}"/>
              </a:ext>
            </a:extLst>
          </p:cNvPr>
          <p:cNvSpPr txBox="1"/>
          <p:nvPr/>
        </p:nvSpPr>
        <p:spPr>
          <a:xfrm rot="18462969">
            <a:off x="308357" y="718181"/>
            <a:ext cx="930273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Rec. MMP-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3AD2233-3338-5B3F-22C7-B999CBFB409B}"/>
              </a:ext>
            </a:extLst>
          </p:cNvPr>
          <p:cNvSpPr txBox="1"/>
          <p:nvPr/>
        </p:nvSpPr>
        <p:spPr>
          <a:xfrm rot="18462969">
            <a:off x="3953841" y="590586"/>
            <a:ext cx="162912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42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B964F95-DD8F-7399-E66F-75DB64077373}"/>
              </a:ext>
            </a:extLst>
          </p:cNvPr>
          <p:cNvSpPr txBox="1"/>
          <p:nvPr/>
        </p:nvSpPr>
        <p:spPr>
          <a:xfrm rot="18462969">
            <a:off x="5308807" y="678902"/>
            <a:ext cx="1243678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425 +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hBsg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xo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73C3A5E-8A81-0290-EF5B-958A9191238D}"/>
              </a:ext>
            </a:extLst>
          </p:cNvPr>
          <p:cNvSpPr txBox="1"/>
          <p:nvPr/>
        </p:nvSpPr>
        <p:spPr>
          <a:xfrm rot="18462969">
            <a:off x="5977951" y="640268"/>
            <a:ext cx="1243678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425 +shMMP2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xo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974F46D-BCA0-6BC6-F5BD-DD7FD237137D}"/>
              </a:ext>
            </a:extLst>
          </p:cNvPr>
          <p:cNvSpPr txBox="1"/>
          <p:nvPr/>
        </p:nvSpPr>
        <p:spPr>
          <a:xfrm>
            <a:off x="278336" y="2237220"/>
            <a:ext cx="638197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Representative </a:t>
            </a:r>
            <a:r>
              <a:rPr lang="en-GB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ull length zymography image from Figure 5F and Supplementary Figure S7</a:t>
            </a:r>
            <a:r>
              <a:rPr lang="en-GB" sz="9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K</a:t>
            </a:r>
            <a:r>
              <a:rPr lang="en-GB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 </a:t>
            </a:r>
            <a:endParaRPr lang="en-GB" sz="900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83A2E86C-DAA9-A70C-9C68-A7FD3EDF4D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5338" y="1467731"/>
            <a:ext cx="6883400" cy="6731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813AB53A-B20E-9D7C-5291-6D73E9CAE3AB}"/>
              </a:ext>
            </a:extLst>
          </p:cNvPr>
          <p:cNvSpPr txBox="1"/>
          <p:nvPr/>
        </p:nvSpPr>
        <p:spPr>
          <a:xfrm rot="18462969">
            <a:off x="856035" y="653310"/>
            <a:ext cx="162912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HLA-0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23730B5-E2D5-BECB-6443-53061C93F9F8}"/>
              </a:ext>
            </a:extLst>
          </p:cNvPr>
          <p:cNvSpPr txBox="1"/>
          <p:nvPr/>
        </p:nvSpPr>
        <p:spPr>
          <a:xfrm rot="18462969">
            <a:off x="1492581" y="600145"/>
            <a:ext cx="162912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HLA-01 +NT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xo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95BAB69-4301-1FF6-2367-1C816C11B8D3}"/>
              </a:ext>
            </a:extLst>
          </p:cNvPr>
          <p:cNvSpPr txBox="1"/>
          <p:nvPr/>
        </p:nvSpPr>
        <p:spPr>
          <a:xfrm rot="18462969">
            <a:off x="2177793" y="607160"/>
            <a:ext cx="1449389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HLA-01 +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hBsg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xo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0A9096F-711D-3864-108D-C79D7225338C}"/>
              </a:ext>
            </a:extLst>
          </p:cNvPr>
          <p:cNvSpPr txBox="1"/>
          <p:nvPr/>
        </p:nvSpPr>
        <p:spPr>
          <a:xfrm rot="18462969">
            <a:off x="2888122" y="688524"/>
            <a:ext cx="1243678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HLA-01 +shMMP2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xo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09915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7573F99DE79145B2C4B20841E12603" ma:contentTypeVersion="14" ma:contentTypeDescription="Create a new document." ma:contentTypeScope="" ma:versionID="70847557c11f4c5d303bab0841afb919">
  <xsd:schema xmlns:xsd="http://www.w3.org/2001/XMLSchema" xmlns:xs="http://www.w3.org/2001/XMLSchema" xmlns:p="http://schemas.microsoft.com/office/2006/metadata/properties" xmlns:ns3="786e620f-b1da-4f59-878c-ef7546d25bf1" xmlns:ns4="0c1e910d-4918-42f1-af2c-ed1101d63abc" targetNamespace="http://schemas.microsoft.com/office/2006/metadata/properties" ma:root="true" ma:fieldsID="106685c28068271dd180d1f213555644" ns3:_="" ns4:_="">
    <xsd:import namespace="786e620f-b1da-4f59-878c-ef7546d25bf1"/>
    <xsd:import namespace="0c1e910d-4918-42f1-af2c-ed1101d63abc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DateTaken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4:MediaLengthInSeconds" minOccurs="0"/>
                <xsd:element ref="ns4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6e620f-b1da-4f59-878c-ef7546d25bf1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c1e910d-4918-42f1-af2c-ed1101d63ab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c1e910d-4918-42f1-af2c-ed1101d63abc" xsi:nil="true"/>
  </documentManagement>
</p:properties>
</file>

<file path=customXml/itemProps1.xml><?xml version="1.0" encoding="utf-8"?>
<ds:datastoreItem xmlns:ds="http://schemas.openxmlformats.org/officeDocument/2006/customXml" ds:itemID="{A659F151-8533-4D42-8DF6-42CF80BD6DA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6e620f-b1da-4f59-878c-ef7546d25bf1"/>
    <ds:schemaRef ds:uri="0c1e910d-4918-42f1-af2c-ed1101d63ab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AA7A94C-2B59-459C-B682-5D9099BE29A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C924079-55E0-4501-8DF7-CF350BAC43BF}">
  <ds:schemaRefs>
    <ds:schemaRef ds:uri="http://purl.org/dc/terms/"/>
    <ds:schemaRef ds:uri="http://schemas.openxmlformats.org/package/2006/metadata/core-properties"/>
    <ds:schemaRef ds:uri="786e620f-b1da-4f59-878c-ef7546d25bf1"/>
    <ds:schemaRef ds:uri="http://purl.org/dc/dcmitype/"/>
    <ds:schemaRef ds:uri="http://schemas.microsoft.com/office/infopath/2007/PartnerControls"/>
    <ds:schemaRef ds:uri="http://schemas.microsoft.com/office/2006/documentManagement/types"/>
    <ds:schemaRef ds:uri="http://schemas.microsoft.com/office/2006/metadata/properties"/>
    <ds:schemaRef ds:uri="0c1e910d-4918-42f1-af2c-ed1101d63abc"/>
    <ds:schemaRef ds:uri="http://www.w3.org/XML/1998/namespace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148</Words>
  <Application>Microsoft Office PowerPoint</Application>
  <PresentationFormat>Widescreen</PresentationFormat>
  <Paragraphs>2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. Jackson</dc:creator>
  <cp:lastModifiedBy>MDPI</cp:lastModifiedBy>
  <cp:revision>9</cp:revision>
  <dcterms:created xsi:type="dcterms:W3CDTF">2023-04-29T17:08:37Z</dcterms:created>
  <dcterms:modified xsi:type="dcterms:W3CDTF">2023-05-04T00:44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7573F99DE79145B2C4B20841E12603</vt:lpwstr>
  </property>
</Properties>
</file>